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4079"/>
  </p:normalViewPr>
  <p:slideViewPr>
    <p:cSldViewPr snapToGrid="0" snapToObjects="1">
      <p:cViewPr varScale="1">
        <p:scale>
          <a:sx n="77" d="100"/>
          <a:sy n="77" d="100"/>
        </p:scale>
        <p:origin x="63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857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213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938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341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684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625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129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406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85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377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955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9DF74-AAFB-7E43-9031-B2E63A3A454D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B70E7-E8E2-6A44-B04D-0517D95A8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501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7517078"/>
              </p:ext>
            </p:extLst>
          </p:nvPr>
        </p:nvGraphicFramePr>
        <p:xfrm>
          <a:off x="3079750" y="1994376"/>
          <a:ext cx="6032500" cy="40138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39583"/>
                <a:gridCol w="1713598"/>
                <a:gridCol w="1713598"/>
                <a:gridCol w="1565721"/>
              </a:tblGrid>
              <a:tr h="17145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</a:tr>
              <a:tr h="29019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Haematology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lotting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Full blood count; clotting; D-Dimer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Full blood count; clotting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69596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iochemistry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Glucose; renal function; protein electrophoresis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Glucose; liver enzymes;</a:t>
                      </a:r>
                      <a:endParaRPr lang="en-US" sz="18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renal function; protein electrophoresis; urine BJP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Glucose; liver enzymes; renal function; protein electrophoresis; urine BJP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157035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icrobiology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lood culture; CrAg;</a:t>
                      </a:r>
                      <a:endParaRPr lang="en-US" sz="18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SF PCRs for polyomavirus JC, HSV, </a:t>
                      </a:r>
                      <a:endParaRPr lang="en-US" sz="18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ZV, CMV, EBV, adenovirus, enterovirus, mumps, measles, mycoplasma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B (sputum microscopy &amp;culture and Interferon Gamma Release Assay);</a:t>
                      </a:r>
                      <a:endParaRPr lang="en-US" sz="18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orrelia burgdorferi; </a:t>
                      </a:r>
                      <a:endParaRPr lang="en-US" sz="18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rucella species; syphilis; HIV; JCV. CSF PCRs for polyomavirus JC; HSV; VZV; CMV and EBV. CSF India Ink and CrAG. 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lood bacterial and fungal culture.</a:t>
                      </a:r>
                      <a:endParaRPr lang="en-US" sz="18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SF PCRs for polyomavirus JC, HSV, TB. CSF India Ink</a:t>
                      </a:r>
                      <a:endParaRPr lang="en-US" sz="18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34734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mmunology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NA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nti-Neuronal antibodies(Hu,Ri,Ma-2)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nti-VGKC and anti-NMDAR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1714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ndocrine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hyroid function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hyroid function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hyroid function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18034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ytology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SF cytology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SF cytology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54165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Other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Urine drug screen; chest X-ray; CT Brain; MRI Brain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T pulmonary angiogram; Electrocardiogram; Brain FDG PET ; Sleep study</a:t>
                      </a:r>
                      <a:endParaRPr lang="en-US" sz="180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T Brain</a:t>
                      </a:r>
                      <a:endParaRPr lang="en-US" sz="1800" dirty="0">
                        <a:solidFill>
                          <a:srgbClr val="000D62"/>
                        </a:solidFill>
                        <a:effectLst/>
                        <a:latin typeface="ArialMT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5" name="Text Box 8"/>
          <p:cNvSpPr txBox="1"/>
          <p:nvPr/>
        </p:nvSpPr>
        <p:spPr>
          <a:xfrm>
            <a:off x="3079750" y="569859"/>
            <a:ext cx="6032500" cy="1277273"/>
          </a:xfrm>
          <a:prstGeom prst="rect">
            <a:avLst/>
          </a:prstGeom>
          <a:noFill/>
          <a:ln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 Supplementary Table. </a:t>
            </a:r>
            <a:r>
              <a:rPr lang="en-US" sz="1100" dirty="0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List of investigations with normal results performed during the first episode of encephalopathy in patient A, B and C. Abbreviations: ANA – antinuclear antigen; BJP – </a:t>
            </a:r>
            <a:r>
              <a:rPr lang="en-US" sz="1100" dirty="0" err="1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Bence</a:t>
            </a:r>
            <a:r>
              <a:rPr lang="en-US" sz="1100" dirty="0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-Jones Protein; CMV – cytomegalovirus; </a:t>
            </a:r>
            <a:r>
              <a:rPr lang="en-US" sz="1100" dirty="0" err="1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CrAg</a:t>
            </a:r>
            <a:r>
              <a:rPr lang="en-US" sz="1100" dirty="0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 – </a:t>
            </a:r>
            <a:r>
              <a:rPr lang="en-US" sz="1100" dirty="0" err="1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Cryptococcal</a:t>
            </a:r>
            <a:r>
              <a:rPr lang="en-US" sz="1100" dirty="0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 antigen; CSF – cerebrospinal fluid; EBV – Epstein Barr Virus; FDG PET – </a:t>
            </a:r>
            <a:r>
              <a:rPr lang="en-US" sz="1100" dirty="0" err="1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Fluorodexoyglucose</a:t>
            </a:r>
            <a:r>
              <a:rPr lang="en-US" sz="1100" dirty="0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 Positron Emission Tomography; HIV – human immunodeficiency virus; HSV – Herpes simplex virus; JCV – John </a:t>
            </a:r>
            <a:r>
              <a:rPr lang="en-US" sz="1100" dirty="0" err="1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Cunnigham</a:t>
            </a:r>
            <a:r>
              <a:rPr lang="en-US" sz="1100" dirty="0">
                <a:solidFill>
                  <a:srgbClr val="000D62"/>
                </a:solidFill>
                <a:effectLst/>
                <a:latin typeface="Calibri" charset="0"/>
                <a:ea typeface="Times New Roman" charset="0"/>
                <a:cs typeface="Times New Roman" charset="0"/>
              </a:rPr>
              <a:t> virus; TB – Mycobacterium tuberculosis; NMDAR – N-methyl-D-aspartic acid receptor; PCR – polymerase chain reaction; VGKC – Voltage-gated potassium channels; VZV – Varicella Zoster Virus.</a:t>
            </a:r>
            <a:endParaRPr lang="en-US" sz="1800" dirty="0">
              <a:solidFill>
                <a:srgbClr val="000D62"/>
              </a:solidFill>
              <a:effectLst/>
              <a:latin typeface="ArialMT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4157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2</Words>
  <Application>Microsoft Macintosh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MT</vt:lpstr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a Crawshaw</dc:creator>
  <cp:lastModifiedBy>Ania Crawshaw</cp:lastModifiedBy>
  <cp:revision>1</cp:revision>
  <dcterms:created xsi:type="dcterms:W3CDTF">2017-11-29T17:51:29Z</dcterms:created>
  <dcterms:modified xsi:type="dcterms:W3CDTF">2017-11-29T17:51:57Z</dcterms:modified>
</cp:coreProperties>
</file>